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</p:sldIdLst>
  <p:sldSz cx="8820150" cy="121681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92"/>
    <p:restoredTop sz="94643"/>
  </p:normalViewPr>
  <p:slideViewPr>
    <p:cSldViewPr snapToGrid="0" snapToObjects="1">
      <p:cViewPr varScale="1">
        <p:scale>
          <a:sx n="51" d="100"/>
          <a:sy n="51" d="100"/>
        </p:scale>
        <p:origin x="2576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1511" y="1991415"/>
            <a:ext cx="7497128" cy="4236332"/>
          </a:xfrm>
        </p:spPr>
        <p:txBody>
          <a:bodyPr anchor="b"/>
          <a:lstStyle>
            <a:lvl1pPr algn="ctr"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2519" y="6391116"/>
            <a:ext cx="6615113" cy="2937828"/>
          </a:xfrm>
        </p:spPr>
        <p:txBody>
          <a:bodyPr/>
          <a:lstStyle>
            <a:lvl1pPr marL="0" indent="0" algn="ctr">
              <a:buNone/>
              <a:defRPr sz="2315"/>
            </a:lvl1pPr>
            <a:lvl2pPr marL="441015" indent="0" algn="ctr">
              <a:buNone/>
              <a:defRPr sz="1929"/>
            </a:lvl2pPr>
            <a:lvl3pPr marL="882030" indent="0" algn="ctr">
              <a:buNone/>
              <a:defRPr sz="1736"/>
            </a:lvl3pPr>
            <a:lvl4pPr marL="1323045" indent="0" algn="ctr">
              <a:buNone/>
              <a:defRPr sz="1543"/>
            </a:lvl4pPr>
            <a:lvl5pPr marL="1764060" indent="0" algn="ctr">
              <a:buNone/>
              <a:defRPr sz="1543"/>
            </a:lvl5pPr>
            <a:lvl6pPr marL="2205076" indent="0" algn="ctr">
              <a:buNone/>
              <a:defRPr sz="1543"/>
            </a:lvl6pPr>
            <a:lvl7pPr marL="2646091" indent="0" algn="ctr">
              <a:buNone/>
              <a:defRPr sz="1543"/>
            </a:lvl7pPr>
            <a:lvl8pPr marL="3087106" indent="0" algn="ctr">
              <a:buNone/>
              <a:defRPr sz="1543"/>
            </a:lvl8pPr>
            <a:lvl9pPr marL="3528121" indent="0" algn="ctr">
              <a:buNone/>
              <a:defRPr sz="154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507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34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11920" y="647843"/>
            <a:ext cx="1901845" cy="103119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6386" y="647843"/>
            <a:ext cx="5595283" cy="103119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36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514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1792" y="3033601"/>
            <a:ext cx="7607379" cy="5061627"/>
          </a:xfrm>
        </p:spPr>
        <p:txBody>
          <a:bodyPr anchor="b"/>
          <a:lstStyle>
            <a:lvl1pPr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1792" y="8143113"/>
            <a:ext cx="7607379" cy="2661790"/>
          </a:xfrm>
        </p:spPr>
        <p:txBody>
          <a:bodyPr/>
          <a:lstStyle>
            <a:lvl1pPr marL="0" indent="0">
              <a:buNone/>
              <a:defRPr sz="2315">
                <a:solidFill>
                  <a:schemeClr val="tx1"/>
                </a:solidFill>
              </a:defRPr>
            </a:lvl1pPr>
            <a:lvl2pPr marL="441015" indent="0">
              <a:buNone/>
              <a:defRPr sz="1929">
                <a:solidFill>
                  <a:schemeClr val="tx1">
                    <a:tint val="75000"/>
                  </a:schemeClr>
                </a:solidFill>
              </a:defRPr>
            </a:lvl2pPr>
            <a:lvl3pPr marL="882030" indent="0">
              <a:buNone/>
              <a:defRPr sz="1736">
                <a:solidFill>
                  <a:schemeClr val="tx1">
                    <a:tint val="75000"/>
                  </a:schemeClr>
                </a:solidFill>
              </a:defRPr>
            </a:lvl3pPr>
            <a:lvl4pPr marL="1323045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4pPr>
            <a:lvl5pPr marL="1764060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5pPr>
            <a:lvl6pPr marL="220507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6pPr>
            <a:lvl7pPr marL="264609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7pPr>
            <a:lvl8pPr marL="308710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8pPr>
            <a:lvl9pPr marL="352812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362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6385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5201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152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647846"/>
            <a:ext cx="7607379" cy="235195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7535" y="2982897"/>
            <a:ext cx="3731336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7535" y="4444769"/>
            <a:ext cx="3731336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65201" y="2982897"/>
            <a:ext cx="3749713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65201" y="4444769"/>
            <a:ext cx="3749713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350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289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4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49713" y="1751997"/>
            <a:ext cx="4465201" cy="8647300"/>
          </a:xfrm>
        </p:spPr>
        <p:txBody>
          <a:bodyPr/>
          <a:lstStyle>
            <a:lvl1pPr>
              <a:defRPr sz="3087"/>
            </a:lvl1pPr>
            <a:lvl2pPr>
              <a:defRPr sz="2701"/>
            </a:lvl2pPr>
            <a:lvl3pPr>
              <a:defRPr sz="2315"/>
            </a:lvl3pPr>
            <a:lvl4pPr>
              <a:defRPr sz="1929"/>
            </a:lvl4pPr>
            <a:lvl5pPr>
              <a:defRPr sz="1929"/>
            </a:lvl5pPr>
            <a:lvl6pPr>
              <a:defRPr sz="1929"/>
            </a:lvl6pPr>
            <a:lvl7pPr>
              <a:defRPr sz="1929"/>
            </a:lvl7pPr>
            <a:lvl8pPr>
              <a:defRPr sz="1929"/>
            </a:lvl8pPr>
            <a:lvl9pPr>
              <a:defRPr sz="192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67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49713" y="1751997"/>
            <a:ext cx="4465201" cy="8647300"/>
          </a:xfrm>
        </p:spPr>
        <p:txBody>
          <a:bodyPr anchor="t"/>
          <a:lstStyle>
            <a:lvl1pPr marL="0" indent="0">
              <a:buNone/>
              <a:defRPr sz="3087"/>
            </a:lvl1pPr>
            <a:lvl2pPr marL="441015" indent="0">
              <a:buNone/>
              <a:defRPr sz="2701"/>
            </a:lvl2pPr>
            <a:lvl3pPr marL="882030" indent="0">
              <a:buNone/>
              <a:defRPr sz="2315"/>
            </a:lvl3pPr>
            <a:lvl4pPr marL="1323045" indent="0">
              <a:buNone/>
              <a:defRPr sz="1929"/>
            </a:lvl4pPr>
            <a:lvl5pPr marL="1764060" indent="0">
              <a:buNone/>
              <a:defRPr sz="1929"/>
            </a:lvl5pPr>
            <a:lvl6pPr marL="2205076" indent="0">
              <a:buNone/>
              <a:defRPr sz="1929"/>
            </a:lvl6pPr>
            <a:lvl7pPr marL="2646091" indent="0">
              <a:buNone/>
              <a:defRPr sz="1929"/>
            </a:lvl7pPr>
            <a:lvl8pPr marL="3087106" indent="0">
              <a:buNone/>
              <a:defRPr sz="1929"/>
            </a:lvl8pPr>
            <a:lvl9pPr marL="3528121" indent="0">
              <a:buNone/>
              <a:defRPr sz="192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68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6386" y="647846"/>
            <a:ext cx="7607379" cy="2351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6386" y="3239216"/>
            <a:ext cx="7607379" cy="77206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6385" y="11278110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7E5C5-5FC9-E748-8AA7-A79C9F4BC107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21675" y="11278110"/>
            <a:ext cx="2976801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29231" y="11278110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067D9-97B7-DB43-A89F-4807CF41C5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868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82030" rtl="0" eaLnBrk="1" latinLnBrk="0" hangingPunct="1">
        <a:lnSpc>
          <a:spcPct val="90000"/>
        </a:lnSpc>
        <a:spcBef>
          <a:spcPct val="0"/>
        </a:spcBef>
        <a:buNone/>
        <a:defRPr sz="42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0508" indent="-220508" algn="l" defTabSz="882030" rtl="0" eaLnBrk="1" latinLnBrk="0" hangingPunct="1">
        <a:lnSpc>
          <a:spcPct val="90000"/>
        </a:lnSpc>
        <a:spcBef>
          <a:spcPts val="965"/>
        </a:spcBef>
        <a:buFont typeface="Arial" panose="020B0604020202020204" pitchFamily="34" charset="0"/>
        <a:buChar char="•"/>
        <a:defRPr sz="2701" kern="1200">
          <a:solidFill>
            <a:schemeClr val="tx1"/>
          </a:solidFill>
          <a:latin typeface="+mn-lt"/>
          <a:ea typeface="+mn-ea"/>
          <a:cs typeface="+mn-cs"/>
        </a:defRPr>
      </a:lvl1pPr>
      <a:lvl2pPr marL="66152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110253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3pPr>
      <a:lvl4pPr marL="154355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98456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42558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86659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748629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1pPr>
      <a:lvl2pPr marL="441015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2pPr>
      <a:lvl3pPr marL="88203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3pPr>
      <a:lvl4pPr marL="1323045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76406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205076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646091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087106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528121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F5E5034-D32F-B849-BD3D-4A86D08EFF9E}"/>
              </a:ext>
            </a:extLst>
          </p:cNvPr>
          <p:cNvGrpSpPr>
            <a:grpSpLocks noChangeAspect="1"/>
          </p:cNvGrpSpPr>
          <p:nvPr/>
        </p:nvGrpSpPr>
        <p:grpSpPr>
          <a:xfrm>
            <a:off x="1000971" y="766119"/>
            <a:ext cx="6847200" cy="8191314"/>
            <a:chOff x="319135" y="0"/>
            <a:chExt cx="8372867" cy="10016471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C91F86E3-24B8-7542-878B-4EB6D1545B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24571" y="74343"/>
              <a:ext cx="4050286" cy="24566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74C6007-91A9-9349-9F4C-5DD2642ABA06}"/>
                </a:ext>
              </a:extLst>
            </p:cNvPr>
            <p:cNvSpPr txBox="1"/>
            <p:nvPr/>
          </p:nvSpPr>
          <p:spPr>
            <a:xfrm>
              <a:off x="7573904" y="74343"/>
              <a:ext cx="11180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F1A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4DDE6F7E-742E-D547-AB9B-823211532E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9135" y="61012"/>
              <a:ext cx="3976114" cy="24522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1BB1E00-A265-4446-9F8B-B2E401EC2204}"/>
                </a:ext>
              </a:extLst>
            </p:cNvPr>
            <p:cNvSpPr txBox="1"/>
            <p:nvPr/>
          </p:nvSpPr>
          <p:spPr>
            <a:xfrm>
              <a:off x="3403736" y="0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T7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D45FF5A0-7585-2746-9C6D-3D181FFFF0E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39183" y="2620117"/>
              <a:ext cx="4003573" cy="21763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480DA08-B3B5-5A47-99E2-75876C7854BD}"/>
                </a:ext>
              </a:extLst>
            </p:cNvPr>
            <p:cNvSpPr txBox="1"/>
            <p:nvPr/>
          </p:nvSpPr>
          <p:spPr>
            <a:xfrm>
              <a:off x="3383393" y="2585599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P2A</a:t>
              </a:r>
            </a:p>
          </p:txBody>
        </p: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90CAC38E-3797-CC4E-8E91-BCA3D5123DE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24571" y="2620117"/>
              <a:ext cx="4050286" cy="21763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7EBCBCF-A5D6-894A-9AB5-16907C54C878}"/>
                </a:ext>
              </a:extLst>
            </p:cNvPr>
            <p:cNvSpPr txBox="1"/>
            <p:nvPr/>
          </p:nvSpPr>
          <p:spPr>
            <a:xfrm>
              <a:off x="7573904" y="2704446"/>
              <a:ext cx="7425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BQ9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49E87CA7-D63C-6648-84B6-09670AEFFB4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19135" y="4903298"/>
              <a:ext cx="4032541" cy="21987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9F18294-54C4-C744-B3A7-77FC8678C4F8}"/>
                </a:ext>
              </a:extLst>
            </p:cNvPr>
            <p:cNvSpPr txBox="1"/>
            <p:nvPr/>
          </p:nvSpPr>
          <p:spPr>
            <a:xfrm>
              <a:off x="3303242" y="4969904"/>
              <a:ext cx="8675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IPS41</a:t>
              </a: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5A3A1C15-747B-1348-A9FA-EF820390E0B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467408" y="4885575"/>
              <a:ext cx="4007449" cy="21930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3FA737F-B36D-5140-993C-8A3702597613}"/>
                </a:ext>
              </a:extLst>
            </p:cNvPr>
            <p:cNvSpPr txBox="1"/>
            <p:nvPr/>
          </p:nvSpPr>
          <p:spPr>
            <a:xfrm>
              <a:off x="7573904" y="5068728"/>
              <a:ext cx="8208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UA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C2799BFE-39A9-6C42-A390-D3B67C59B06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192247" y="7185499"/>
              <a:ext cx="4550322" cy="28309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8510F22-4BAF-384E-BADB-CD6AE82B8880}"/>
                </a:ext>
              </a:extLst>
            </p:cNvPr>
            <p:cNvSpPr txBox="1"/>
            <p:nvPr/>
          </p:nvSpPr>
          <p:spPr>
            <a:xfrm>
              <a:off x="5933717" y="7252105"/>
              <a:ext cx="8088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C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B4DED46D-5608-224C-9E99-77705932AF8D}"/>
              </a:ext>
            </a:extLst>
          </p:cNvPr>
          <p:cNvSpPr txBox="1"/>
          <p:nvPr/>
        </p:nvSpPr>
        <p:spPr>
          <a:xfrm>
            <a:off x="598875" y="9099305"/>
            <a:ext cx="8112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1 Fig: Melt curve generated for all the seven candidate reference gene in </a:t>
            </a:r>
            <a:r>
              <a:rPr kumimoji="0" lang="en-US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. juncea</a:t>
            </a:r>
          </a:p>
        </p:txBody>
      </p:sp>
    </p:spTree>
    <p:extLst>
      <p:ext uri="{BB962C8B-B14F-4D97-AF65-F5344CB8AC3E}">
        <p14:creationId xmlns:p14="http://schemas.microsoft.com/office/powerpoint/2010/main" val="946209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24</Words>
  <Application>Microsoft Macintosh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kha dixit</dc:creator>
  <cp:lastModifiedBy>Microsoft Office User</cp:lastModifiedBy>
  <cp:revision>4</cp:revision>
  <dcterms:created xsi:type="dcterms:W3CDTF">2019-04-06T05:29:01Z</dcterms:created>
  <dcterms:modified xsi:type="dcterms:W3CDTF">2019-09-06T14:35:05Z</dcterms:modified>
</cp:coreProperties>
</file>